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xime:Desktop:Ms%20Dal80%20Revision%2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xime:Desktop:Ms%20Dal80%20Revision%2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rillon\Desktop\S1A%20Fi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luster 15-35 bp'!$B$9</c:f>
              <c:strCache>
                <c:ptCount val="1"/>
                <c:pt idx="0">
                  <c:v>Dal80-boun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</c:spPr>
          <c:invertIfNegative val="0"/>
          <c:cat>
            <c:strRef>
              <c:f>'cluster 15-35 bp'!$C$8:$D$8</c:f>
              <c:strCache>
                <c:ptCount val="2"/>
                <c:pt idx="0">
                  <c:v>GATA cluster</c:v>
                </c:pt>
                <c:pt idx="1">
                  <c:v>no cluster</c:v>
                </c:pt>
              </c:strCache>
            </c:strRef>
          </c:cat>
          <c:val>
            <c:numRef>
              <c:f>'cluster 15-35 bp'!$C$9:$D$9</c:f>
              <c:numCache>
                <c:formatCode>0.000</c:formatCode>
                <c:ptCount val="2"/>
                <c:pt idx="0">
                  <c:v>9.6926713947990545E-2</c:v>
                </c:pt>
                <c:pt idx="1">
                  <c:v>0.90307328605200898</c:v>
                </c:pt>
              </c:numCache>
            </c:numRef>
          </c:val>
        </c:ser>
        <c:ser>
          <c:idx val="1"/>
          <c:order val="1"/>
          <c:tx>
            <c:strRef>
              <c:f>'cluster 15-35 bp'!$B$10</c:f>
              <c:strCache>
                <c:ptCount val="1"/>
                <c:pt idx="0">
                  <c:v>Unboun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'cluster 15-35 bp'!$C$8:$D$8</c:f>
              <c:strCache>
                <c:ptCount val="2"/>
                <c:pt idx="0">
                  <c:v>GATA cluster</c:v>
                </c:pt>
                <c:pt idx="1">
                  <c:v>no cluster</c:v>
                </c:pt>
              </c:strCache>
            </c:strRef>
          </c:cat>
          <c:val>
            <c:numRef>
              <c:f>'cluster 15-35 bp'!$C$10:$D$10</c:f>
              <c:numCache>
                <c:formatCode>0.000</c:formatCode>
                <c:ptCount val="2"/>
                <c:pt idx="0">
                  <c:v>9.8476484875248418E-2</c:v>
                </c:pt>
                <c:pt idx="1">
                  <c:v>0.901523515124751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493947152"/>
        <c:axId val="-1493943344"/>
      </c:barChart>
      <c:catAx>
        <c:axId val="-14939471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93943344"/>
        <c:crosses val="autoZero"/>
        <c:auto val="1"/>
        <c:lblAlgn val="ctr"/>
        <c:lblOffset val="100"/>
        <c:noMultiLvlLbl val="0"/>
      </c:catAx>
      <c:valAx>
        <c:axId val="-1493943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Arial" pitchFamily="34" charset="0"/>
                    <a:cs typeface="Arial" pitchFamily="34" charset="0"/>
                  </a:defRPr>
                </a:pPr>
                <a:r>
                  <a:rPr lang="en-US" sz="900">
                    <a:latin typeface="Arial" pitchFamily="34" charset="0"/>
                    <a:cs typeface="Arial" pitchFamily="34" charset="0"/>
                  </a:rPr>
                  <a:t>Proportion of genes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93947152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luster 15-35 bp'!$N$8</c:f>
              <c:strCache>
                <c:ptCount val="1"/>
                <c:pt idx="0">
                  <c:v>Dal80-boun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15-35 bp'!$O$7:$R$7</c:f>
              <c:strCache>
                <c:ptCount val="4"/>
                <c:pt idx="0">
                  <c:v>H-H</c:v>
                </c:pt>
                <c:pt idx="1">
                  <c:v>H-T</c:v>
                </c:pt>
                <c:pt idx="2">
                  <c:v>T-H</c:v>
                </c:pt>
                <c:pt idx="3">
                  <c:v>T-T</c:v>
                </c:pt>
              </c:strCache>
            </c:strRef>
          </c:cat>
          <c:val>
            <c:numRef>
              <c:f>'cluster 15-35 bp'!$O$8:$R$8</c:f>
              <c:numCache>
                <c:formatCode>0.00</c:formatCode>
                <c:ptCount val="4"/>
                <c:pt idx="0">
                  <c:v>0.17391304347826148</c:v>
                </c:pt>
                <c:pt idx="1">
                  <c:v>0.28985507246376802</c:v>
                </c:pt>
                <c:pt idx="2">
                  <c:v>0.30434782608695632</c:v>
                </c:pt>
                <c:pt idx="3">
                  <c:v>0.231884057971014</c:v>
                </c:pt>
              </c:numCache>
            </c:numRef>
          </c:val>
        </c:ser>
        <c:ser>
          <c:idx val="1"/>
          <c:order val="1"/>
          <c:tx>
            <c:strRef>
              <c:f>'cluster 15-35 bp'!$N$9</c:f>
              <c:strCache>
                <c:ptCount val="1"/>
                <c:pt idx="0">
                  <c:v>Unboun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cluster 15-35 bp'!$O$7:$R$7</c:f>
              <c:strCache>
                <c:ptCount val="4"/>
                <c:pt idx="0">
                  <c:v>H-H</c:v>
                </c:pt>
                <c:pt idx="1">
                  <c:v>H-T</c:v>
                </c:pt>
                <c:pt idx="2">
                  <c:v>T-H</c:v>
                </c:pt>
                <c:pt idx="3">
                  <c:v>T-T</c:v>
                </c:pt>
              </c:strCache>
            </c:strRef>
          </c:cat>
          <c:val>
            <c:numRef>
              <c:f>'cluster 15-35 bp'!$O$9:$R$9</c:f>
              <c:numCache>
                <c:formatCode>0.00</c:formatCode>
                <c:ptCount val="4"/>
                <c:pt idx="0">
                  <c:v>0.19635627530364375</c:v>
                </c:pt>
                <c:pt idx="1">
                  <c:v>0.313765182186235</c:v>
                </c:pt>
                <c:pt idx="2">
                  <c:v>0.29554655870445351</c:v>
                </c:pt>
                <c:pt idx="3">
                  <c:v>0.194331983805668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493942256"/>
        <c:axId val="-1493941168"/>
      </c:barChart>
      <c:catAx>
        <c:axId val="-14939422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Arial" pitchFamily="34" charset="0"/>
                    <a:cs typeface="Arial" pitchFamily="34" charset="0"/>
                  </a:defRPr>
                </a:pPr>
                <a:r>
                  <a:rPr lang="fr-FR" sz="900" baseline="0" dirty="0" smtClean="0">
                    <a:latin typeface="Arial" pitchFamily="34" charset="0"/>
                    <a:cs typeface="Arial" pitchFamily="34" charset="0"/>
                  </a:rPr>
                  <a:t>Orientation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93941168"/>
        <c:crosses val="autoZero"/>
        <c:auto val="1"/>
        <c:lblAlgn val="ctr"/>
        <c:lblOffset val="100"/>
        <c:noMultiLvlLbl val="0"/>
      </c:catAx>
      <c:valAx>
        <c:axId val="-14939411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Arial" pitchFamily="34" charset="0"/>
                    <a:cs typeface="Arial" pitchFamily="34" charset="0"/>
                  </a:defRPr>
                </a:pPr>
                <a:r>
                  <a:rPr lang="fr-FR" sz="900">
                    <a:latin typeface="Arial" pitchFamily="34" charset="0"/>
                    <a:cs typeface="Arial" pitchFamily="34" charset="0"/>
                  </a:rPr>
                  <a:t>Proportion of clusters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939422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F4'!$F$2:$F$7</c:f>
                <c:numCache>
                  <c:formatCode>General</c:formatCode>
                  <c:ptCount val="6"/>
                  <c:pt idx="0">
                    <c:v>2.6684053165780472E-3</c:v>
                  </c:pt>
                  <c:pt idx="1">
                    <c:v>0.46615979912902977</c:v>
                  </c:pt>
                  <c:pt idx="2">
                    <c:v>3.9824234504342746E-3</c:v>
                  </c:pt>
                  <c:pt idx="3">
                    <c:v>3.4240637281665594</c:v>
                  </c:pt>
                  <c:pt idx="4">
                    <c:v>8.0595411381438121E-4</c:v>
                  </c:pt>
                  <c:pt idx="5">
                    <c:v>0.96540981142382865</c:v>
                  </c:pt>
                </c:numCache>
              </c:numRef>
            </c:plus>
            <c:minus>
              <c:numRef>
                <c:f>'UF4'!$F$2:$F$7</c:f>
                <c:numCache>
                  <c:formatCode>General</c:formatCode>
                  <c:ptCount val="6"/>
                  <c:pt idx="0">
                    <c:v>2.6684053165780472E-3</c:v>
                  </c:pt>
                  <c:pt idx="1">
                    <c:v>0.46615979912902977</c:v>
                  </c:pt>
                  <c:pt idx="2">
                    <c:v>3.9824234504342746E-3</c:v>
                  </c:pt>
                  <c:pt idx="3">
                    <c:v>3.4240637281665594</c:v>
                  </c:pt>
                  <c:pt idx="4">
                    <c:v>8.0595411381438121E-4</c:v>
                  </c:pt>
                  <c:pt idx="5">
                    <c:v>0.96540981142382865</c:v>
                  </c:pt>
                </c:numCache>
              </c:numRef>
            </c:minus>
          </c:errBars>
          <c:cat>
            <c:strRef>
              <c:f>'UF4'!$D$2:$D$7</c:f>
              <c:strCache>
                <c:ptCount val="6"/>
                <c:pt idx="0">
                  <c:v>Gln</c:v>
                </c:pt>
                <c:pt idx="1">
                  <c:v>Pro</c:v>
                </c:pt>
                <c:pt idx="2">
                  <c:v>Gln</c:v>
                </c:pt>
                <c:pt idx="3">
                  <c:v>Pro</c:v>
                </c:pt>
                <c:pt idx="4">
                  <c:v>Gln</c:v>
                </c:pt>
                <c:pt idx="5">
                  <c:v>Pro</c:v>
                </c:pt>
              </c:strCache>
            </c:strRef>
          </c:cat>
          <c:val>
            <c:numRef>
              <c:f>'UF4'!$E$2:$E$7</c:f>
              <c:numCache>
                <c:formatCode>0.00</c:formatCode>
                <c:ptCount val="6"/>
                <c:pt idx="0">
                  <c:v>4.6773430506768403E-2</c:v>
                </c:pt>
                <c:pt idx="1">
                  <c:v>6.296709165641257</c:v>
                </c:pt>
                <c:pt idx="2">
                  <c:v>4.6128966034811314E-2</c:v>
                </c:pt>
                <c:pt idx="3">
                  <c:v>15.578132301289692</c:v>
                </c:pt>
                <c:pt idx="4">
                  <c:v>3.8797220489360268E-2</c:v>
                </c:pt>
                <c:pt idx="5">
                  <c:v>5.02224388644724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786411968"/>
        <c:axId val="-1448173872"/>
      </c:barChart>
      <c:catAx>
        <c:axId val="-1786411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448173872"/>
        <c:crosses val="autoZero"/>
        <c:auto val="1"/>
        <c:lblAlgn val="ctr"/>
        <c:lblOffset val="100"/>
        <c:noMultiLvlLbl val="0"/>
      </c:catAx>
      <c:valAx>
        <c:axId val="-144817387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-1786411968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.xml"/><Relationship Id="rId5" Type="http://schemas.openxmlformats.org/officeDocument/2006/relationships/image" Target="../media/image2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ZoneTexte 133"/>
          <p:cNvSpPr txBox="1"/>
          <p:nvPr/>
        </p:nvSpPr>
        <p:spPr>
          <a:xfrm>
            <a:off x="1" y="864000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e 20"/>
          <p:cNvGrpSpPr/>
          <p:nvPr/>
        </p:nvGrpSpPr>
        <p:grpSpPr>
          <a:xfrm>
            <a:off x="4461307" y="296964"/>
            <a:ext cx="1527027" cy="2498288"/>
            <a:chOff x="890637" y="490297"/>
            <a:chExt cx="1527027" cy="2498288"/>
          </a:xfrm>
        </p:grpSpPr>
        <p:sp>
          <p:nvSpPr>
            <p:cNvPr id="112" name="ZoneTexte 111"/>
            <p:cNvSpPr txBox="1"/>
            <p:nvPr/>
          </p:nvSpPr>
          <p:spPr>
            <a:xfrm rot="16200000">
              <a:off x="1073169" y="2748776"/>
              <a:ext cx="2487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3" name="ZoneTexte 112"/>
            <p:cNvSpPr txBox="1"/>
            <p:nvPr/>
          </p:nvSpPr>
          <p:spPr>
            <a:xfrm rot="16200000">
              <a:off x="548235" y="1664613"/>
              <a:ext cx="915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stance 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fr-F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4" name="ZoneTexte 113"/>
            <p:cNvSpPr txBox="1"/>
            <p:nvPr/>
          </p:nvSpPr>
          <p:spPr>
            <a:xfrm rot="16200000">
              <a:off x="1041109" y="2352071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5" name="ZoneTexte 114"/>
            <p:cNvSpPr txBox="1"/>
            <p:nvPr/>
          </p:nvSpPr>
          <p:spPr>
            <a:xfrm rot="16200000">
              <a:off x="1009049" y="1954852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6" name="ZoneTexte 115"/>
            <p:cNvSpPr txBox="1"/>
            <p:nvPr/>
          </p:nvSpPr>
          <p:spPr>
            <a:xfrm rot="16200000">
              <a:off x="1009049" y="1533524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7" name="ZoneTexte 116"/>
            <p:cNvSpPr txBox="1"/>
            <p:nvPr/>
          </p:nvSpPr>
          <p:spPr>
            <a:xfrm rot="16200000">
              <a:off x="1009049" y="1136049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18" name="ZoneTexte 117"/>
            <p:cNvSpPr txBox="1"/>
            <p:nvPr/>
          </p:nvSpPr>
          <p:spPr>
            <a:xfrm rot="16200000">
              <a:off x="1009049" y="730623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1117307" y="490297"/>
              <a:ext cx="1300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SS-ATG distance</a:t>
              </a:r>
            </a:p>
          </p:txBody>
        </p:sp>
        <p:pic>
          <p:nvPicPr>
            <p:cNvPr id="20" name="Image 19" descr="boxplot_TSS_ATG_distance.png"/>
            <p:cNvPicPr>
              <a:picLocks noChangeAspect="1"/>
            </p:cNvPicPr>
            <p:nvPr/>
          </p:nvPicPr>
          <p:blipFill>
            <a:blip r:embed="rId2" cstate="print"/>
            <a:srcRect l="21469" t="11431" r="9977" b="14216"/>
            <a:stretch>
              <a:fillRect/>
            </a:stretch>
          </p:blipFill>
          <p:spPr>
            <a:xfrm>
              <a:off x="1256306" y="714483"/>
              <a:ext cx="1001278" cy="2266396"/>
            </a:xfrm>
            <a:prstGeom prst="rect">
              <a:avLst/>
            </a:prstGeom>
          </p:spPr>
        </p:pic>
      </p:grpSp>
      <p:sp>
        <p:nvSpPr>
          <p:cNvPr id="145" name="ZoneTexte 144"/>
          <p:cNvSpPr txBox="1"/>
          <p:nvPr/>
        </p:nvSpPr>
        <p:spPr>
          <a:xfrm>
            <a:off x="4219600" y="153646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ZoneTexte 145"/>
          <p:cNvSpPr txBox="1"/>
          <p:nvPr/>
        </p:nvSpPr>
        <p:spPr>
          <a:xfrm>
            <a:off x="784401" y="5462619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3" name="Graphique 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3675043"/>
              </p:ext>
            </p:extLst>
          </p:nvPr>
        </p:nvGraphicFramePr>
        <p:xfrm>
          <a:off x="433316" y="3500195"/>
          <a:ext cx="1667997" cy="1917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4" name="Graphique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7910485"/>
              </p:ext>
            </p:extLst>
          </p:nvPr>
        </p:nvGraphicFramePr>
        <p:xfrm>
          <a:off x="3070418" y="3500813"/>
          <a:ext cx="2779777" cy="2026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1" name="ZoneTexte 60"/>
          <p:cNvSpPr txBox="1"/>
          <p:nvPr/>
        </p:nvSpPr>
        <p:spPr>
          <a:xfrm>
            <a:off x="265777" y="283514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2888961" y="283514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252129" y="153646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Groupe 67"/>
          <p:cNvGrpSpPr/>
          <p:nvPr/>
        </p:nvGrpSpPr>
        <p:grpSpPr>
          <a:xfrm>
            <a:off x="2051088" y="3729371"/>
            <a:ext cx="893456" cy="392977"/>
            <a:chOff x="3551802" y="3980517"/>
            <a:chExt cx="893456" cy="392977"/>
          </a:xfrm>
        </p:grpSpPr>
        <p:sp>
          <p:nvSpPr>
            <p:cNvPr id="64" name="Rectangle 63"/>
            <p:cNvSpPr/>
            <p:nvPr/>
          </p:nvSpPr>
          <p:spPr>
            <a:xfrm>
              <a:off x="3551802" y="4223295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3551802" y="4053835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3600155" y="4142662"/>
              <a:ext cx="652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bound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3600155" y="3980517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l80-</a:t>
              </a:r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ound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693085" y="3015106"/>
            <a:ext cx="16129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uster of 2 GATA sites</a:t>
            </a:r>
          </a:p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5-35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istance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3515455" y="3015106"/>
            <a:ext cx="23871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ientation of GATA sites in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sters</a:t>
            </a:r>
            <a:endParaRPr lang="fr-FR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5-35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istance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 sites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3" name="Groupe 72"/>
          <p:cNvGrpSpPr/>
          <p:nvPr/>
        </p:nvGrpSpPr>
        <p:grpSpPr>
          <a:xfrm>
            <a:off x="5810760" y="3729371"/>
            <a:ext cx="893456" cy="392977"/>
            <a:chOff x="3551802" y="3980517"/>
            <a:chExt cx="893456" cy="392977"/>
          </a:xfrm>
        </p:grpSpPr>
        <p:sp>
          <p:nvSpPr>
            <p:cNvPr id="74" name="Rectangle 73"/>
            <p:cNvSpPr/>
            <p:nvPr/>
          </p:nvSpPr>
          <p:spPr>
            <a:xfrm>
              <a:off x="3551802" y="4223295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3551802" y="4053835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3600155" y="4142662"/>
              <a:ext cx="652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bound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3600155" y="3980517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l80-</a:t>
              </a:r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ound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Groupe 89"/>
          <p:cNvGrpSpPr/>
          <p:nvPr/>
        </p:nvGrpSpPr>
        <p:grpSpPr>
          <a:xfrm>
            <a:off x="1100793" y="5613804"/>
            <a:ext cx="4523140" cy="2810605"/>
            <a:chOff x="1100793" y="5613804"/>
            <a:chExt cx="4523140" cy="2810605"/>
          </a:xfrm>
        </p:grpSpPr>
        <p:grpSp>
          <p:nvGrpSpPr>
            <p:cNvPr id="4" name="Groupe 56"/>
            <p:cNvGrpSpPr/>
            <p:nvPr/>
          </p:nvGrpSpPr>
          <p:grpSpPr>
            <a:xfrm>
              <a:off x="1100793" y="7862778"/>
              <a:ext cx="4523140" cy="561631"/>
              <a:chOff x="2210256" y="2769138"/>
              <a:chExt cx="4523140" cy="561631"/>
            </a:xfrm>
          </p:grpSpPr>
          <p:sp>
            <p:nvSpPr>
              <p:cNvPr id="58" name="ZoneTexte 57"/>
              <p:cNvSpPr txBox="1"/>
              <p:nvPr/>
            </p:nvSpPr>
            <p:spPr>
              <a:xfrm>
                <a:off x="2223828" y="2992215"/>
                <a:ext cx="45095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CCCACGGG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itchFamily="49" charset="0"/>
                    <a:cs typeface="Courier New" pitchFamily="49" charset="0"/>
                  </a:rPr>
                  <a:t>AATAAG</a:t>
                </a:r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GCAGCC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itchFamily="49" charset="0"/>
                    <a:cs typeface="Courier New" pitchFamily="49" charset="0"/>
                  </a:rPr>
                  <a:t>GACAA</a:t>
                </a:r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AA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itchFamily="49" charset="0"/>
                    <a:cs typeface="Courier New" pitchFamily="49" charset="0"/>
                  </a:rPr>
                  <a:t>GAAAA</a:t>
                </a:r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ACGACC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itchFamily="49" charset="0"/>
                    <a:cs typeface="Courier New" pitchFamily="49" charset="0"/>
                  </a:rPr>
                  <a:t>GAAAAG</a:t>
                </a:r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GAACCAGAAA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itchFamily="49" charset="0"/>
                    <a:cs typeface="Courier New" pitchFamily="49" charset="0"/>
                  </a:rPr>
                  <a:t>GAAAA</a:t>
                </a:r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AAGAGGGTGGGC</a:t>
                </a:r>
              </a:p>
              <a:p>
                <a:r>
                  <a:rPr lang="en-US" sz="800" dirty="0" smtClean="0">
                    <a:latin typeface="Courier New" pitchFamily="49" charset="0"/>
                    <a:cs typeface="Courier New" pitchFamily="49" charset="0"/>
                  </a:rPr>
                  <a:t>        *             *      *          *               *</a:t>
                </a:r>
                <a:endParaRPr lang="fr-FR" sz="8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2250161" y="3004668"/>
                <a:ext cx="4383753" cy="25512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2210256" y="2769138"/>
                <a:ext cx="12170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err="1" smtClean="0">
                    <a:latin typeface="Arial" pitchFamily="34" charset="0"/>
                    <a:cs typeface="Arial" pitchFamily="34" charset="0"/>
                  </a:rPr>
                  <a:t>chr</a:t>
                </a:r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.16 432100-170 :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oupe 142"/>
            <p:cNvGrpSpPr/>
            <p:nvPr/>
          </p:nvGrpSpPr>
          <p:grpSpPr>
            <a:xfrm>
              <a:off x="1760548" y="7556370"/>
              <a:ext cx="3300454" cy="425565"/>
              <a:chOff x="2935846" y="2552490"/>
              <a:chExt cx="3300454" cy="425565"/>
            </a:xfrm>
          </p:grpSpPr>
          <p:grpSp>
            <p:nvGrpSpPr>
              <p:cNvPr id="6" name="Groupe 57"/>
              <p:cNvGrpSpPr/>
              <p:nvPr/>
            </p:nvGrpSpPr>
            <p:grpSpPr>
              <a:xfrm>
                <a:off x="2962428" y="2578142"/>
                <a:ext cx="3273872" cy="399913"/>
                <a:chOff x="2694701" y="2951033"/>
                <a:chExt cx="3273872" cy="399913"/>
              </a:xfrm>
            </p:grpSpPr>
            <p:sp>
              <p:nvSpPr>
                <p:cNvPr id="47" name="Flèche droite 46"/>
                <p:cNvSpPr/>
                <p:nvPr/>
              </p:nvSpPr>
              <p:spPr>
                <a:xfrm>
                  <a:off x="3814794" y="2951033"/>
                  <a:ext cx="1296000" cy="180000"/>
                </a:xfrm>
                <a:prstGeom prst="rightArrow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8" name="ZoneTexte 47"/>
                <p:cNvSpPr txBox="1"/>
                <p:nvPr/>
              </p:nvSpPr>
              <p:spPr>
                <a:xfrm>
                  <a:off x="4166886" y="3104725"/>
                  <a:ext cx="5196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 smtClean="0">
                      <a:latin typeface="Arial" pitchFamily="34" charset="0"/>
                      <a:cs typeface="Arial" pitchFamily="34" charset="0"/>
                    </a:rPr>
                    <a:t>ALD6</a:t>
                  </a:r>
                  <a:endParaRPr lang="fr-FR" sz="1000" b="1" i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Flèche droite 48"/>
                <p:cNvSpPr/>
                <p:nvPr/>
              </p:nvSpPr>
              <p:spPr>
                <a:xfrm>
                  <a:off x="5212573" y="2951033"/>
                  <a:ext cx="756000" cy="180000"/>
                </a:xfrm>
                <a:prstGeom prst="rightArrow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0" name="Flèche droite 49"/>
                <p:cNvSpPr/>
                <p:nvPr/>
              </p:nvSpPr>
              <p:spPr>
                <a:xfrm>
                  <a:off x="2694701" y="2951033"/>
                  <a:ext cx="324000" cy="180000"/>
                </a:xfrm>
                <a:prstGeom prst="rightArrow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7" name="Groupe 141"/>
              <p:cNvGrpSpPr/>
              <p:nvPr/>
            </p:nvGrpSpPr>
            <p:grpSpPr>
              <a:xfrm>
                <a:off x="2976638" y="2626871"/>
                <a:ext cx="3096000" cy="72000"/>
                <a:chOff x="2976638" y="2599129"/>
                <a:chExt cx="3096000" cy="72000"/>
              </a:xfrm>
            </p:grpSpPr>
            <p:cxnSp>
              <p:nvCxnSpPr>
                <p:cNvPr id="43" name="Connecteur droit 42"/>
                <p:cNvCxnSpPr/>
                <p:nvPr/>
              </p:nvCxnSpPr>
              <p:spPr>
                <a:xfrm>
                  <a:off x="5878433" y="2599129"/>
                  <a:ext cx="0" cy="360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Connecteur droit 43"/>
                <p:cNvCxnSpPr/>
                <p:nvPr/>
              </p:nvCxnSpPr>
              <p:spPr>
                <a:xfrm>
                  <a:off x="5965417" y="2635129"/>
                  <a:ext cx="0" cy="360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Connecteur droit 45"/>
                <p:cNvCxnSpPr/>
                <p:nvPr/>
              </p:nvCxnSpPr>
              <p:spPr>
                <a:xfrm>
                  <a:off x="5993119" y="2635129"/>
                  <a:ext cx="0" cy="360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3" name="Line 5">
                  <a:extLst>
                    <a:ext uri="{FF2B5EF4-FFF2-40B4-BE49-F238E27FC236}">
                      <a16:creationId xmlns:a16="http://schemas.microsoft.com/office/drawing/2014/main" xmlns="" id="{C4F1B8BD-D63B-4A3C-A01C-0CEADE4E92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76638" y="2635129"/>
                  <a:ext cx="30960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BE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" name="Groupe 137"/>
              <p:cNvGrpSpPr/>
              <p:nvPr/>
            </p:nvGrpSpPr>
            <p:grpSpPr>
              <a:xfrm>
                <a:off x="2935846" y="2552490"/>
                <a:ext cx="136571" cy="220763"/>
                <a:chOff x="2616087" y="4739851"/>
                <a:chExt cx="136571" cy="220763"/>
              </a:xfrm>
            </p:grpSpPr>
            <p:cxnSp>
              <p:nvCxnSpPr>
                <p:cNvPr id="136" name="Connecteur droit 135"/>
                <p:cNvCxnSpPr/>
                <p:nvPr/>
              </p:nvCxnSpPr>
              <p:spPr>
                <a:xfrm flipH="1">
                  <a:off x="2616087" y="4739851"/>
                  <a:ext cx="108000" cy="21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Connecteur droit 136"/>
                <p:cNvCxnSpPr/>
                <p:nvPr/>
              </p:nvCxnSpPr>
              <p:spPr>
                <a:xfrm flipH="1">
                  <a:off x="2644658" y="4744614"/>
                  <a:ext cx="108000" cy="21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" name="Groupe 138"/>
              <p:cNvGrpSpPr/>
              <p:nvPr/>
            </p:nvGrpSpPr>
            <p:grpSpPr>
              <a:xfrm>
                <a:off x="5999742" y="2552490"/>
                <a:ext cx="136571" cy="220763"/>
                <a:chOff x="2616087" y="4739851"/>
                <a:chExt cx="136571" cy="220763"/>
              </a:xfrm>
            </p:grpSpPr>
            <p:cxnSp>
              <p:nvCxnSpPr>
                <p:cNvPr id="140" name="Connecteur droit 139"/>
                <p:cNvCxnSpPr/>
                <p:nvPr/>
              </p:nvCxnSpPr>
              <p:spPr>
                <a:xfrm flipH="1">
                  <a:off x="2616087" y="4739851"/>
                  <a:ext cx="108000" cy="21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Connecteur droit 140"/>
                <p:cNvCxnSpPr/>
                <p:nvPr/>
              </p:nvCxnSpPr>
              <p:spPr>
                <a:xfrm flipH="1">
                  <a:off x="2644658" y="4744614"/>
                  <a:ext cx="108000" cy="21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9" name="Groupe 88"/>
            <p:cNvGrpSpPr/>
            <p:nvPr/>
          </p:nvGrpSpPr>
          <p:grpSpPr>
            <a:xfrm>
              <a:off x="1300821" y="5613804"/>
              <a:ext cx="3880327" cy="1978544"/>
              <a:chOff x="1300821" y="5613804"/>
              <a:chExt cx="3880327" cy="1978544"/>
            </a:xfrm>
          </p:grpSpPr>
          <p:pic>
            <p:nvPicPr>
              <p:cNvPr id="26" name="Image 25" descr="YPL061W.png"/>
              <p:cNvPicPr preferRelativeResize="0">
                <a:picLocks/>
              </p:cNvPicPr>
              <p:nvPr/>
            </p:nvPicPr>
            <p:blipFill>
              <a:blip r:embed="rId5" cstate="print"/>
              <a:srcRect l="3801" t="12001" r="2751" b="28000"/>
              <a:stretch>
                <a:fillRect/>
              </a:stretch>
            </p:blipFill>
            <p:spPr>
              <a:xfrm>
                <a:off x="1810527" y="5863489"/>
                <a:ext cx="3096000" cy="1512000"/>
              </a:xfrm>
              <a:prstGeom prst="rect">
                <a:avLst/>
              </a:prstGeom>
            </p:spPr>
          </p:pic>
          <p:sp>
            <p:nvSpPr>
              <p:cNvPr id="27" name="ZoneTexte 26"/>
              <p:cNvSpPr txBox="1"/>
              <p:nvPr/>
            </p:nvSpPr>
            <p:spPr>
              <a:xfrm rot="16200000">
                <a:off x="1572637" y="719418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 rot="16200000">
                <a:off x="1508517" y="6826516"/>
                <a:ext cx="3770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>
                    <a:latin typeface="Arial" pitchFamily="34" charset="0"/>
                    <a:cs typeface="Arial" pitchFamily="34" charset="0"/>
                  </a:rPr>
                  <a:t>100</a:t>
                </a:r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 rot="16200000">
                <a:off x="1508517" y="6104597"/>
                <a:ext cx="3770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3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 rot="16200000">
                <a:off x="1025898" y="6554119"/>
                <a:ext cx="102464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 err="1">
                    <a:latin typeface="Arial" pitchFamily="34" charset="0"/>
                    <a:cs typeface="Arial" pitchFamily="34" charset="0"/>
                  </a:rPr>
                  <a:t>Density</a:t>
                </a:r>
                <a:r>
                  <a:rPr lang="fr-FR" sz="900" b="1" dirty="0">
                    <a:latin typeface="Arial" pitchFamily="34" charset="0"/>
                    <a:cs typeface="Arial" pitchFamily="34" charset="0"/>
                  </a:rPr>
                  <a:t> (tag/nt)</a:t>
                </a: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 rot="16200000">
                <a:off x="1508517" y="6462796"/>
                <a:ext cx="3770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1696928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14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2180735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20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>
                <a:off x="2668614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26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3152342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32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>
                <a:off x="3641412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38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>
                <a:off x="4122760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44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1300821" y="7361516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err="1">
                    <a:latin typeface="Arial" pitchFamily="34" charset="0"/>
                    <a:cs typeface="Arial" pitchFamily="34" charset="0"/>
                  </a:rPr>
                  <a:t>chr</a:t>
                </a:r>
                <a:r>
                  <a:rPr lang="fr-FR" sz="900" dirty="0">
                    <a:latin typeface="Arial" pitchFamily="34" charset="0"/>
                    <a:cs typeface="Arial" pitchFamily="34" charset="0"/>
                  </a:rPr>
                  <a:t>.16</a:t>
                </a: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4611761" y="7361516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435000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2540821" y="5912946"/>
                <a:ext cx="72000" cy="1368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>
                <a:off x="1745750" y="5613804"/>
                <a:ext cx="25314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IP</a:t>
                </a:r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fr-F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q</a:t>
                </a:r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gnal (GATA-</a:t>
                </a:r>
                <a:r>
                  <a:rPr lang="fr-F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s</a:t>
                </a:r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moter</a:t>
                </a:r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ZoneTexte 86"/>
              <p:cNvSpPr txBox="1"/>
              <p:nvPr/>
            </p:nvSpPr>
            <p:spPr>
              <a:xfrm>
                <a:off x="3830843" y="6010649"/>
                <a:ext cx="5597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ag</a:t>
                </a:r>
              </a:p>
            </p:txBody>
          </p:sp>
          <p:sp>
            <p:nvSpPr>
              <p:cNvPr id="88" name="ZoneTexte 87"/>
              <p:cNvSpPr txBox="1"/>
              <p:nvPr/>
            </p:nvSpPr>
            <p:spPr>
              <a:xfrm>
                <a:off x="3830843" y="6157622"/>
                <a:ext cx="8931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l80-Myc</a:t>
                </a:r>
                <a:r>
                  <a:rPr lang="fr-FR" sz="1000" baseline="300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</p:grpSp>
      <p:grpSp>
        <p:nvGrpSpPr>
          <p:cNvPr id="122" name="Groupe 121"/>
          <p:cNvGrpSpPr/>
          <p:nvPr/>
        </p:nvGrpSpPr>
        <p:grpSpPr>
          <a:xfrm>
            <a:off x="542224" y="341284"/>
            <a:ext cx="3258251" cy="2418155"/>
            <a:chOff x="542224" y="341284"/>
            <a:chExt cx="3258251" cy="2418155"/>
          </a:xfrm>
        </p:grpSpPr>
        <p:sp>
          <p:nvSpPr>
            <p:cNvPr id="124" name="Rectangle 53"/>
            <p:cNvSpPr>
              <a:spLocks noChangeArrowheads="1"/>
            </p:cNvSpPr>
            <p:nvPr/>
          </p:nvSpPr>
          <p:spPr bwMode="auto">
            <a:xfrm>
              <a:off x="1187787" y="341284"/>
              <a:ext cx="118622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DAL5</a:t>
              </a:r>
              <a:r>
                <a:rPr kumimoji="0" lang="fr-FR" sz="1000" b="1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  </a:t>
              </a:r>
              <a:r>
                <a:rPr kumimoji="0" lang="fr-FR" sz="1000" b="1" u="none" strike="noStrike" cap="none" normalizeH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mRNA</a:t>
              </a:r>
              <a:r>
                <a:rPr kumimoji="0" lang="fr-FR" sz="1000" b="1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kumimoji="0" lang="fr-FR" sz="1000" b="1" u="none" strike="noStrike" cap="none" normalizeH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levels</a:t>
              </a:r>
              <a:endParaRPr kumimoji="0" lang="fr-FR" sz="10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25" name="Rectangle 53"/>
            <p:cNvSpPr>
              <a:spLocks noChangeArrowheads="1"/>
            </p:cNvSpPr>
            <p:nvPr/>
          </p:nvSpPr>
          <p:spPr bwMode="auto">
            <a:xfrm rot="16200000">
              <a:off x="-13647" y="1090338"/>
              <a:ext cx="138874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SPT15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-</a:t>
              </a:r>
              <a:r>
                <a:rPr kumimoji="0" lang="fr-FR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normalized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kumimoji="0" lang="fr-FR" sz="9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expression </a:t>
              </a:r>
              <a:r>
                <a:rPr kumimoji="0" lang="fr-FR" sz="9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levels</a:t>
              </a:r>
              <a:endParaRPr kumimoji="0" lang="fr-FR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26" name="ZoneTexte 125"/>
            <p:cNvSpPr txBox="1"/>
            <p:nvPr/>
          </p:nvSpPr>
          <p:spPr>
            <a:xfrm>
              <a:off x="2808769" y="2528607"/>
              <a:ext cx="8418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smtClean="0">
                  <a:latin typeface="Arial" pitchFamily="34" charset="0"/>
                  <a:cs typeface="Arial" pitchFamily="34" charset="0"/>
                </a:rPr>
                <a:t>Dal80-Myc</a:t>
              </a:r>
              <a:r>
                <a:rPr lang="fr-FR" sz="900" b="1" baseline="30000" dirty="0" smtClean="0">
                  <a:latin typeface="Arial" pitchFamily="34" charset="0"/>
                  <a:cs typeface="Arial" pitchFamily="34" charset="0"/>
                </a:rPr>
                <a:t>13</a:t>
              </a:r>
              <a:endParaRPr lang="fr-FR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2114514" y="2528607"/>
              <a:ext cx="5501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i="1" dirty="0" smtClean="0">
                  <a:latin typeface="Arial" pitchFamily="34" charset="0"/>
                  <a:cs typeface="Arial" pitchFamily="34" charset="0"/>
                </a:rPr>
                <a:t>dal80</a:t>
              </a:r>
              <a:r>
                <a:rPr lang="fr-FR" sz="900" b="1" i="1" dirty="0" smtClean="0">
                  <a:latin typeface="Symbol" pitchFamily="18" charset="2"/>
                  <a:cs typeface="Arial" pitchFamily="34" charset="0"/>
                </a:rPr>
                <a:t>D</a:t>
              </a:r>
              <a:endParaRPr lang="fr-FR" sz="900" b="1" i="1" baseline="300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128" name="ZoneTexte 127"/>
            <p:cNvSpPr txBox="1"/>
            <p:nvPr/>
          </p:nvSpPr>
          <p:spPr>
            <a:xfrm>
              <a:off x="1357982" y="2528607"/>
              <a:ext cx="3642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fr-FR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9" name="Connecteur droit 128"/>
            <p:cNvCxnSpPr/>
            <p:nvPr/>
          </p:nvCxnSpPr>
          <p:spPr>
            <a:xfrm>
              <a:off x="2065663" y="2507501"/>
              <a:ext cx="64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cteur droit 129"/>
            <p:cNvCxnSpPr/>
            <p:nvPr/>
          </p:nvCxnSpPr>
          <p:spPr>
            <a:xfrm>
              <a:off x="1216083" y="2507501"/>
              <a:ext cx="64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130"/>
            <p:cNvCxnSpPr/>
            <p:nvPr/>
          </p:nvCxnSpPr>
          <p:spPr>
            <a:xfrm>
              <a:off x="2915243" y="2507501"/>
              <a:ext cx="64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35" name="Graphique 134"/>
            <p:cNvGraphicFramePr/>
            <p:nvPr/>
          </p:nvGraphicFramePr>
          <p:xfrm>
            <a:off x="809624" y="428624"/>
            <a:ext cx="2990851" cy="2105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3</TotalTime>
  <Words>114</Words>
  <Application>Microsoft Office PowerPoint</Application>
  <PresentationFormat>Affichage à l'écran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88</cp:revision>
  <dcterms:created xsi:type="dcterms:W3CDTF">2017-04-24T12:24:59Z</dcterms:created>
  <dcterms:modified xsi:type="dcterms:W3CDTF">2019-01-31T06:37:53Z</dcterms:modified>
</cp:coreProperties>
</file>